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66" r:id="rId4"/>
    <p:sldId id="268" r:id="rId5"/>
    <p:sldId id="258" r:id="rId6"/>
    <p:sldId id="260" r:id="rId7"/>
    <p:sldId id="261" r:id="rId8"/>
    <p:sldId id="263" r:id="rId9"/>
    <p:sldId id="264" r:id="rId10"/>
    <p:sldId id="269" r:id="rId11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35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102" y="4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altLang="zh-CN"/>
              <a:t>Click to edit Master subtitle style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0F712-7250-4DE9-A3F7-C62258E506FF}" type="datetimeFigureOut">
              <a:rPr lang="zh-CN" altLang="en-US" smtClean="0"/>
              <a:t>2022/9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D08F94-144F-4DA4-B5C8-51FE51AC25A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465248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zh-CN"/>
              <a:t>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0F712-7250-4DE9-A3F7-C62258E506FF}" type="datetimeFigureOut">
              <a:rPr lang="zh-CN" altLang="en-US" smtClean="0"/>
              <a:t>2022/9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D08F94-144F-4DA4-B5C8-51FE51AC25A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978370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altLang="zh-CN"/>
              <a:t>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0F712-7250-4DE9-A3F7-C62258E506FF}" type="datetimeFigureOut">
              <a:rPr lang="zh-CN" altLang="en-US" smtClean="0"/>
              <a:t>2022/9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D08F94-144F-4DA4-B5C8-51FE51AC25A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181898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altLang="zh-CN"/>
              <a:t>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0F712-7250-4DE9-A3F7-C62258E506FF}" type="datetimeFigureOut">
              <a:rPr lang="zh-CN" altLang="en-US" smtClean="0"/>
              <a:t>2022/9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D08F94-144F-4DA4-B5C8-51FE51AC25A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034908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altLang="zh-CN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0F712-7250-4DE9-A3F7-C62258E506FF}" type="datetimeFigureOut">
              <a:rPr lang="zh-CN" altLang="en-US" smtClean="0"/>
              <a:t>2022/9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D08F94-144F-4DA4-B5C8-51FE51AC25A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581145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altLang="zh-CN"/>
              <a:t>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altLang="zh-CN"/>
              <a:t>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0F712-7250-4DE9-A3F7-C62258E506FF}" type="datetimeFigureOut">
              <a:rPr lang="zh-CN" altLang="en-US" smtClean="0"/>
              <a:t>2022/9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D08F94-144F-4DA4-B5C8-51FE51AC25A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600929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zh-CN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altLang="zh-CN"/>
              <a:t>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zh-CN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altLang="zh-CN"/>
              <a:t>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0F712-7250-4DE9-A3F7-C62258E506FF}" type="datetimeFigureOut">
              <a:rPr lang="zh-CN" altLang="en-US" smtClean="0"/>
              <a:t>2022/9/2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D08F94-144F-4DA4-B5C8-51FE51AC25A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545548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0F712-7250-4DE9-A3F7-C62258E506FF}" type="datetimeFigureOut">
              <a:rPr lang="zh-CN" altLang="en-US" smtClean="0"/>
              <a:t>2022/9/2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D08F94-144F-4DA4-B5C8-51FE51AC25A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851876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0F712-7250-4DE9-A3F7-C62258E506FF}" type="datetimeFigureOut">
              <a:rPr lang="zh-CN" altLang="en-US" smtClean="0"/>
              <a:t>2022/9/2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D08F94-144F-4DA4-B5C8-51FE51AC25A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212195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altLang="zh-CN"/>
              <a:t>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altLang="zh-CN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0F712-7250-4DE9-A3F7-C62258E506FF}" type="datetimeFigureOut">
              <a:rPr lang="zh-CN" altLang="en-US" smtClean="0"/>
              <a:t>2022/9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D08F94-144F-4DA4-B5C8-51FE51AC25A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624507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altLang="zh-CN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0F712-7250-4DE9-A3F7-C62258E506FF}" type="datetimeFigureOut">
              <a:rPr lang="zh-CN" altLang="en-US" smtClean="0"/>
              <a:t>2022/9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D08F94-144F-4DA4-B5C8-51FE51AC25A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562314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zh-CN"/>
              <a:t>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A0F712-7250-4DE9-A3F7-C62258E506FF}" type="datetimeFigureOut">
              <a:rPr lang="zh-CN" altLang="en-US" smtClean="0"/>
              <a:t>2022/9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D08F94-144F-4DA4-B5C8-51FE51AC25A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460096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62595" y="1069125"/>
            <a:ext cx="8015845" cy="4007923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1853623" y="5550453"/>
            <a:ext cx="8124817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 </a:t>
            </a:r>
            <a:r>
              <a:rPr lang="en-US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</a:t>
            </a:r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alignment plot 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hows our mitochondrial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omes assembled</a:t>
            </a:r>
            <a:r>
              <a: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Bank ID AB038556.2 of Japanese eels. </a:t>
            </a:r>
            <a:endParaRPr lang="zh-CN" altLang="en-US" sz="16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8109919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638019" y="6003902"/>
            <a:ext cx="9284447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 </a:t>
            </a:r>
            <a:r>
              <a:rPr lang="en-US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0</a:t>
            </a:r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arative genomic analysis of the Japanese eel (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 japonica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arpons (</a:t>
            </a:r>
            <a:r>
              <a:rPr lang="en-US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galops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yprinoides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arowanas (</a:t>
            </a:r>
            <a:r>
              <a:rPr lang="en-US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cleropages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rmosus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1275008" y="1090815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6386188" y="1108398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</a:p>
        </p:txBody>
      </p:sp>
      <p:grpSp>
        <p:nvGrpSpPr>
          <p:cNvPr id="14" name="Group 13"/>
          <p:cNvGrpSpPr/>
          <p:nvPr/>
        </p:nvGrpSpPr>
        <p:grpSpPr>
          <a:xfrm>
            <a:off x="6500321" y="1399765"/>
            <a:ext cx="4236102" cy="4410844"/>
            <a:chOff x="6500321" y="1399765"/>
            <a:chExt cx="4236102" cy="4410844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 rotWithShape="1">
            <a:blip r:embed="rId2"/>
            <a:srcRect l="3404" t="3957" b="3079"/>
            <a:stretch/>
          </p:blipFill>
          <p:spPr>
            <a:xfrm>
              <a:off x="6778304" y="1661375"/>
              <a:ext cx="3958119" cy="3902298"/>
            </a:xfrm>
            <a:prstGeom prst="rect">
              <a:avLst/>
            </a:prstGeom>
          </p:spPr>
        </p:pic>
        <p:sp>
          <p:nvSpPr>
            <p:cNvPr id="8" name="TextBox 7"/>
            <p:cNvSpPr txBox="1"/>
            <p:nvPr/>
          </p:nvSpPr>
          <p:spPr>
            <a:xfrm>
              <a:off x="7273614" y="1399765"/>
              <a:ext cx="282801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ter-genomic Comparison (21,762 gene pairs)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8039849" y="5533610"/>
              <a:ext cx="129554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guilla japonica</a:t>
              </a:r>
            </a:p>
          </p:txBody>
        </p:sp>
        <p:sp>
          <p:nvSpPr>
            <p:cNvPr id="11" name="Rectangle 10"/>
            <p:cNvSpPr/>
            <p:nvPr/>
          </p:nvSpPr>
          <p:spPr>
            <a:xfrm rot="16200000">
              <a:off x="5852836" y="3474024"/>
              <a:ext cx="157196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i="1" dirty="0" err="1">
                  <a:latin typeface="Times New Roman" panose="02020603050405020304" pitchFamily="18" charset="0"/>
                  <a:ea typeface="Times New Roman" panose="02020603050405020304" pitchFamily="18" charset="0"/>
                </a:rPr>
                <a:t>Scleropages</a:t>
              </a:r>
              <a:r>
                <a:rPr lang="en-US" sz="1200" i="1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 </a:t>
              </a:r>
              <a:r>
                <a:rPr lang="en-US" sz="1200" i="1" dirty="0" err="1">
                  <a:latin typeface="Times New Roman" panose="02020603050405020304" pitchFamily="18" charset="0"/>
                  <a:ea typeface="Times New Roman" panose="02020603050405020304" pitchFamily="18" charset="0"/>
                </a:rPr>
                <a:t>formosus</a:t>
              </a:r>
              <a:r>
                <a:rPr lang="en-US" sz="120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 </a:t>
              </a:r>
              <a:endParaRPr lang="en-US" sz="1200" dirty="0"/>
            </a:p>
          </p:txBody>
        </p:sp>
      </p:grpSp>
      <p:grpSp>
        <p:nvGrpSpPr>
          <p:cNvPr id="13" name="Group 12"/>
          <p:cNvGrpSpPr/>
          <p:nvPr/>
        </p:nvGrpSpPr>
        <p:grpSpPr>
          <a:xfrm>
            <a:off x="1275008" y="1399765"/>
            <a:ext cx="4390075" cy="4410843"/>
            <a:chOff x="1275008" y="1399765"/>
            <a:chExt cx="4390075" cy="4410843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 rotWithShape="1">
            <a:blip r:embed="rId3"/>
            <a:srcRect l="2888" t="4570" b="3972"/>
            <a:stretch/>
          </p:blipFill>
          <p:spPr>
            <a:xfrm>
              <a:off x="1551963" y="1687132"/>
              <a:ext cx="4113120" cy="3837905"/>
            </a:xfrm>
            <a:prstGeom prst="rect">
              <a:avLst/>
            </a:prstGeom>
          </p:spPr>
        </p:pic>
        <p:sp>
          <p:nvSpPr>
            <p:cNvPr id="7" name="TextBox 6"/>
            <p:cNvSpPr txBox="1"/>
            <p:nvPr/>
          </p:nvSpPr>
          <p:spPr>
            <a:xfrm>
              <a:off x="2133344" y="1399765"/>
              <a:ext cx="282801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ter-genomic Comparison (23,457 gene pairs)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2899579" y="5533609"/>
              <a:ext cx="129554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guilla japonica</a:t>
              </a:r>
            </a:p>
          </p:txBody>
        </p:sp>
        <p:sp>
          <p:nvSpPr>
            <p:cNvPr id="12" name="Rectangle 11"/>
            <p:cNvSpPr/>
            <p:nvPr/>
          </p:nvSpPr>
          <p:spPr>
            <a:xfrm rot="16200000">
              <a:off x="619059" y="3482487"/>
              <a:ext cx="158889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i="1" dirty="0" err="1">
                  <a:latin typeface="Times New Roman" panose="02020603050405020304" pitchFamily="18" charset="0"/>
                  <a:ea typeface="Times New Roman" panose="02020603050405020304" pitchFamily="18" charset="0"/>
                </a:rPr>
                <a:t>Megalops</a:t>
              </a:r>
              <a:r>
                <a:rPr lang="en-US" sz="1200" i="1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 </a:t>
              </a:r>
              <a:r>
                <a:rPr lang="en-US" sz="1200" i="1" dirty="0" err="1">
                  <a:latin typeface="Times New Roman" panose="02020603050405020304" pitchFamily="18" charset="0"/>
                  <a:ea typeface="Times New Roman" panose="02020603050405020304" pitchFamily="18" charset="0"/>
                </a:rPr>
                <a:t>cyprinoides</a:t>
              </a:r>
              <a:r>
                <a:rPr lang="en-US" sz="1200" i="1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 </a:t>
              </a:r>
              <a:endParaRPr lang="en-US" sz="1200" dirty="0"/>
            </a:p>
          </p:txBody>
        </p:sp>
      </p:grpSp>
    </p:spTree>
    <p:extLst>
      <p:ext uri="{BB962C8B-B14F-4D97-AF65-F5344CB8AC3E}">
        <p14:creationId xmlns:p14="http://schemas.microsoft.com/office/powerpoint/2010/main" val="257855813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99416" y="301831"/>
            <a:ext cx="5187434" cy="5187434"/>
          </a:xfrm>
          <a:prstGeom prst="rect">
            <a:avLst/>
          </a:prstGeom>
        </p:spPr>
      </p:pic>
      <p:sp>
        <p:nvSpPr>
          <p:cNvPr id="7" name="Rectangle 6"/>
          <p:cNvSpPr/>
          <p:nvPr/>
        </p:nvSpPr>
        <p:spPr>
          <a:xfrm>
            <a:off x="2611226" y="5596841"/>
            <a:ext cx="6763813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 </a:t>
            </a:r>
            <a:r>
              <a:rPr lang="en-US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2</a:t>
            </a:r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zh-CN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ircos</a:t>
            </a:r>
            <a:r>
              <a: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lot</a:t>
            </a:r>
            <a:r>
              <a: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zh-CN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tochondrial genome of Japanese eel.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om outer to inner circle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protein-coding</a:t>
            </a:r>
            <a:r>
              <a: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s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rRNA and tRNA; depth of Illumina short-reads; GC content. </a:t>
            </a:r>
            <a:endParaRPr lang="zh-CN" altLang="en-US" sz="16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9829462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1584121" y="5787124"/>
            <a:ext cx="7097300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 </a:t>
            </a:r>
            <a:r>
              <a:rPr lang="en-US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3</a:t>
            </a:r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ulti-platform</a:t>
            </a:r>
            <a:r>
              <a: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Japanese eel genome</a:t>
            </a:r>
            <a:r>
              <a: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ssembly.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31925" y="695325"/>
            <a:ext cx="8515350" cy="47053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3020303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2473134" y="6096181"/>
            <a:ext cx="6778444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 S</a:t>
            </a:r>
            <a:r>
              <a:rPr lang="en-US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nome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arison of Japanese (</a:t>
            </a:r>
            <a:r>
              <a:rPr lang="en-US" altLang="zh-CN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 japonica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European (</a:t>
            </a:r>
            <a:r>
              <a:rPr lang="en-US" altLang="zh-CN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 anguilla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eels.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" name="Group 2"/>
          <p:cNvGrpSpPr/>
          <p:nvPr/>
        </p:nvGrpSpPr>
        <p:grpSpPr>
          <a:xfrm>
            <a:off x="2611073" y="189936"/>
            <a:ext cx="5917499" cy="5766395"/>
            <a:chOff x="2578800" y="329786"/>
            <a:chExt cx="5917499" cy="5766395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593" t="4587" b="6617"/>
            <a:stretch/>
          </p:blipFill>
          <p:spPr>
            <a:xfrm>
              <a:off x="3020036" y="637563"/>
              <a:ext cx="5476263" cy="5150841"/>
            </a:xfrm>
            <a:prstGeom prst="rect">
              <a:avLst/>
            </a:prstGeom>
          </p:spPr>
        </p:pic>
        <p:sp>
          <p:nvSpPr>
            <p:cNvPr id="2" name="TextBox 1"/>
            <p:cNvSpPr txBox="1"/>
            <p:nvPr/>
          </p:nvSpPr>
          <p:spPr>
            <a:xfrm>
              <a:off x="5020625" y="5788404"/>
              <a:ext cx="147508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guilla japonica</a:t>
              </a:r>
            </a:p>
          </p:txBody>
        </p:sp>
        <p:sp>
          <p:nvSpPr>
            <p:cNvPr id="6" name="TextBox 5"/>
            <p:cNvSpPr txBox="1"/>
            <p:nvPr/>
          </p:nvSpPr>
          <p:spPr>
            <a:xfrm rot="16200000">
              <a:off x="2010376" y="2926051"/>
              <a:ext cx="144462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guilla </a:t>
              </a:r>
              <a:r>
                <a:rPr lang="en-US" sz="14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nguilla</a:t>
              </a:r>
              <a:endPara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3800606" y="329786"/>
              <a:ext cx="359066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ter-genomic Comparison (19,457 gene pairs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99111582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2604615" y="5628659"/>
            <a:ext cx="6840263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 S</a:t>
            </a:r>
            <a:r>
              <a:rPr lang="en-US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zh-CN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enn diagram</a:t>
            </a:r>
            <a:r>
              <a: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</a:t>
            </a:r>
            <a:r>
              <a: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notation</a:t>
            </a:r>
            <a:r>
              <a: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sed</a:t>
            </a:r>
            <a:r>
              <a: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n</a:t>
            </a:r>
            <a:r>
              <a: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ve databases (NR, </a:t>
            </a:r>
            <a:r>
              <a:rPr lang="en-US" altLang="zh-CN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terPro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KEGG, </a:t>
            </a:r>
            <a:r>
              <a:rPr lang="en-US" altLang="zh-CN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wissProt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nd KOG). 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34211" y="257904"/>
            <a:ext cx="4981070" cy="498107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5937497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91873" y="911225"/>
            <a:ext cx="6527007" cy="4351338"/>
          </a:xfrm>
        </p:spPr>
      </p:pic>
      <p:sp>
        <p:nvSpPr>
          <p:cNvPr id="5" name="Rectangle 4"/>
          <p:cNvSpPr/>
          <p:nvPr/>
        </p:nvSpPr>
        <p:spPr>
          <a:xfrm>
            <a:off x="3332039" y="5675518"/>
            <a:ext cx="5646674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 </a:t>
            </a:r>
            <a:r>
              <a:rPr lang="en-US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6</a:t>
            </a:r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EGG </a:t>
            </a:r>
            <a:r>
              <a: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sed</a:t>
            </a:r>
            <a:r>
              <a: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 function classification. The</a:t>
            </a:r>
            <a:r>
              <a: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s</a:t>
            </a:r>
            <a:r>
              <a: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</a:t>
            </a:r>
            <a:r>
              <a: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ow</a:t>
            </a:r>
            <a:r>
              <a: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ny</a:t>
            </a:r>
            <a:r>
              <a: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s</a:t>
            </a:r>
            <a:r>
              <a: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re in</a:t>
            </a:r>
            <a:r>
              <a:rPr lang="zh-CN" alt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rticular</a:t>
            </a:r>
            <a:r>
              <a: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unctions</a:t>
            </a:r>
            <a:r>
              <a: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 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9762236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01429" y="581386"/>
            <a:ext cx="4879284" cy="4879284"/>
          </a:xfr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F54D77D2-6FE2-E983-1769-565DE05E8955}"/>
              </a:ext>
            </a:extLst>
          </p:cNvPr>
          <p:cNvSpPr/>
          <p:nvPr/>
        </p:nvSpPr>
        <p:spPr>
          <a:xfrm>
            <a:off x="3332039" y="5675518"/>
            <a:ext cx="5646674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 S</a:t>
            </a:r>
            <a:r>
              <a:rPr lang="en-US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</a:t>
            </a:r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OG </a:t>
            </a:r>
            <a:r>
              <a: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sed</a:t>
            </a:r>
            <a:r>
              <a: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 function classification. The</a:t>
            </a:r>
            <a:r>
              <a: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s</a:t>
            </a:r>
            <a:r>
              <a: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</a:t>
            </a:r>
            <a:r>
              <a: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ow</a:t>
            </a:r>
            <a:r>
              <a: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ny</a:t>
            </a:r>
            <a:r>
              <a: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s</a:t>
            </a:r>
            <a:r>
              <a: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re in</a:t>
            </a:r>
            <a:r>
              <a:rPr lang="zh-CN" alt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rticular</a:t>
            </a:r>
            <a:r>
              <a: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unctions</a:t>
            </a:r>
            <a:r>
              <a: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 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5310484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67078" y="1165444"/>
            <a:ext cx="6173521" cy="4630141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504765" y="1229990"/>
            <a:ext cx="2791346" cy="2094123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1260786" y="5903161"/>
            <a:ext cx="9572165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 </a:t>
            </a:r>
            <a:r>
              <a:rPr lang="en-US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8</a:t>
            </a:r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ngth</a:t>
            </a:r>
            <a:r>
              <a: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stribution of mRNA, CDS, exon, intron and the number of exon in Japanese eel and the</a:t>
            </a:r>
            <a:r>
              <a: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ther species (</a:t>
            </a:r>
            <a:r>
              <a:rPr lang="en-US" altLang="zh-CN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 anguilla, A. </a:t>
            </a:r>
            <a:r>
              <a:rPr lang="en-US" altLang="zh-CN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ostrata</a:t>
            </a:r>
            <a:r>
              <a:rPr lang="en-US" altLang="zh-CN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L. </a:t>
            </a:r>
            <a:r>
              <a:rPr lang="en-US" altLang="zh-CN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culatus</a:t>
            </a:r>
            <a:r>
              <a:rPr lang="en-US" altLang="zh-CN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M. </a:t>
            </a:r>
            <a:r>
              <a:rPr lang="en-US" altLang="zh-CN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yprinoides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33689793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1828799" y="5914936"/>
            <a:ext cx="8372819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 </a:t>
            </a:r>
            <a:r>
              <a:rPr lang="en-US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9</a:t>
            </a:r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s distributions of </a:t>
            </a:r>
            <a:r>
              <a:rPr lang="en-US" altLang="zh-CN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yntenic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aralogs and orthologs. Ks value distribution is used to identify genome duplication and speciation.</a:t>
            </a:r>
          </a:p>
        </p:txBody>
      </p:sp>
      <p:grpSp>
        <p:nvGrpSpPr>
          <p:cNvPr id="3" name="Group 2"/>
          <p:cNvGrpSpPr/>
          <p:nvPr/>
        </p:nvGrpSpPr>
        <p:grpSpPr>
          <a:xfrm>
            <a:off x="1297940" y="1155330"/>
            <a:ext cx="10232572" cy="4559789"/>
            <a:chOff x="1297940" y="1155330"/>
            <a:chExt cx="10232572" cy="4559789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297940" y="1155330"/>
              <a:ext cx="9484360" cy="4559789"/>
            </a:xfrm>
            <a:prstGeom prst="rect">
              <a:avLst/>
            </a:prstGeom>
          </p:spPr>
        </p:pic>
        <p:sp>
          <p:nvSpPr>
            <p:cNvPr id="2" name="TextBox 1"/>
            <p:cNvSpPr txBox="1"/>
            <p:nvPr/>
          </p:nvSpPr>
          <p:spPr>
            <a:xfrm>
              <a:off x="10270157" y="1655546"/>
              <a:ext cx="80509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(paralogs)</a:t>
              </a: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10201618" y="1849266"/>
              <a:ext cx="80509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(paralogs)</a:t>
              </a: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10725420" y="2042986"/>
              <a:ext cx="80509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(paralogs)</a:t>
              </a: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10193653" y="2236706"/>
              <a:ext cx="79380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(</a:t>
              </a:r>
              <a:r>
                <a:rPr lang="en-US" sz="1200" dirty="0" err="1">
                  <a:solidFill>
                    <a:schemeClr val="tx1">
                      <a:lumMod val="75000"/>
                      <a:lumOff val="25000"/>
                    </a:schemeClr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orthlogs</a:t>
              </a:r>
              <a:r>
                <a:rPr lang="en-US" sz="1200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)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10217937" y="2430426"/>
              <a:ext cx="79380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(</a:t>
              </a:r>
              <a:r>
                <a:rPr lang="en-US" sz="1200" dirty="0" err="1">
                  <a:solidFill>
                    <a:schemeClr val="tx1">
                      <a:lumMod val="75000"/>
                      <a:lumOff val="25000"/>
                    </a:schemeClr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orthlogs</a:t>
              </a:r>
              <a:r>
                <a:rPr lang="en-US" sz="1200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)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10218603" y="2624146"/>
              <a:ext cx="79380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(</a:t>
              </a:r>
              <a:r>
                <a:rPr lang="en-US" sz="1200" dirty="0" err="1">
                  <a:solidFill>
                    <a:schemeClr val="tx1">
                      <a:lumMod val="75000"/>
                      <a:lumOff val="25000"/>
                    </a:schemeClr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orthlogs</a:t>
              </a:r>
              <a:r>
                <a:rPr lang="en-US" sz="1200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230388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178</TotalTime>
  <Words>307</Words>
  <Application>Microsoft Office PowerPoint</Application>
  <PresentationFormat>Widescreen</PresentationFormat>
  <Paragraphs>27</Paragraphs>
  <Slides>10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6" baseType="lpstr">
      <vt:lpstr>等线</vt:lpstr>
      <vt:lpstr>等线 Light</vt:lpstr>
      <vt:lpstr>Arial</vt:lpstr>
      <vt:lpstr>Calibri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ang Hongbo</dc:creator>
  <cp:lastModifiedBy>Wong Chris K C</cp:lastModifiedBy>
  <cp:revision>36</cp:revision>
  <dcterms:created xsi:type="dcterms:W3CDTF">2022-04-27T06:36:12Z</dcterms:created>
  <dcterms:modified xsi:type="dcterms:W3CDTF">2022-09-26T06:22:59Z</dcterms:modified>
</cp:coreProperties>
</file>